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D3C4AA-5E7B-C247-C1F2-BAF5BE1DE0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9DDAF24-0066-7AE3-A639-AA070D1076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628EA2-4D81-2B73-DB95-8E61961C3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E6EB-0F18-478D-80CA-98A04370EC3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AA8AB4-8DD6-4FC2-E450-8095BD87D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E173D1-8ED3-A0F6-77C3-952D23939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36C34-6B31-437C-8257-023F2ED9DC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2909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AFB4C0-80BE-F642-AC21-20C9D7EA8F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A4CB90-67AF-ADCF-7AFF-51FBD2C1DB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0B497B-D018-AF44-B615-A26D883501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E6EB-0F18-478D-80CA-98A04370EC3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C57181-1ED9-0D86-3842-05660F29E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291CB9-12AA-008D-D29B-5027C66E8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36C34-6B31-437C-8257-023F2ED9DC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402906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565087C-F528-2729-4D30-D8CCCB9CA9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42C68F-F1A2-3915-EEF9-26FF0B1F87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9D8B2A-79E7-00F6-CEAA-41E1D0C4D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E6EB-0F18-478D-80CA-98A04370EC3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6FA7BF-83AF-1632-F94D-D7FBFF76E0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C230A4-8949-1B27-5C0A-3EF6AD1AF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36C34-6B31-437C-8257-023F2ED9DC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04484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EFAECE-89DB-A156-FCB9-DEF014094C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8C234E-2A36-188D-7E7A-336113DD93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3343CE-D1AC-468C-8C50-65F44093D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E6EB-0F18-478D-80CA-98A04370EC3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23A2BF-0B52-11B8-7663-269B4A743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719606-C350-6C30-643F-9AE664920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36C34-6B31-437C-8257-023F2ED9DC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83928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D165C5-3386-07C3-17E2-505C26D7F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67B4E9-252A-3E85-D179-FDE3B033CA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4FAE45-7897-1290-7FC3-0F5567ECFE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E6EB-0F18-478D-80CA-98A04370EC3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0179DB-B2EB-2B0E-0C35-79EBAC05C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D35FDF-CED7-98AA-709B-571C2E529B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36C34-6B31-437C-8257-023F2ED9DC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0165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04CE82-FC39-2EB4-536A-D4695608C3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C484EB-4B6A-44F6-7B49-75D18FD42E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535692-020F-9092-D45C-607490C4A1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D642FF-07ED-58E9-10B9-1AE5A1938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E6EB-0F18-478D-80CA-98A04370EC3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BDE2E5-230F-4BB2-4807-E5918B0CA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DF4886-72B7-669C-8454-CDF0D8004F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36C34-6B31-437C-8257-023F2ED9DC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9516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2B6C88-9081-3673-62D2-2E845EFEFA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35D025-E832-A6FE-1959-498A30482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AA04C7-ADC2-8B1C-B5E8-E774EBD159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E64F241-43E0-3DB2-30FB-CC4C9AE0DD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BBAD1D9-2947-4249-0E31-16B91DBCCD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0BD96F-00EF-6773-9010-975944942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E6EB-0F18-478D-80CA-98A04370EC3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831F641-5428-6102-1CCD-15401576F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BD72DEC-703F-3B8A-1129-A9BB59CBE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36C34-6B31-437C-8257-023F2ED9DC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17975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221C9-3FEC-0CFB-72B4-D61A8B5FA1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993336-1AE1-DCCD-5FFE-06D9C3987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E6EB-0F18-478D-80CA-98A04370EC3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B09909D-A215-D944-6AF9-E4CB4291D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3A46689-F93B-4152-AE32-193E6DB12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36C34-6B31-437C-8257-023F2ED9DC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14085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4D34B0-FE6A-DB82-8137-FD709A9DE7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E6EB-0F18-478D-80CA-98A04370EC3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A675346-0B45-A365-94EB-6A24003AD2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A7E7C6-F058-7627-E514-9FB3EE488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36C34-6B31-437C-8257-023F2ED9DC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65280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634ED3-DB71-3BA0-E1D2-CA851ECEFC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141B77-DE47-31D5-382F-6FFB14332A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41C02F-F6E4-958A-8B7F-FD4D7423C3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48711B-03FE-D3D8-15CC-89B3D7FD5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E6EB-0F18-478D-80CA-98A04370EC3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169B3A-EC17-8422-D919-67FFAB9793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62D797-985B-76C3-4101-3445785F90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36C34-6B31-437C-8257-023F2ED9DC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48886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B7B336-4C9E-7E5E-40FB-0EC4E5EAE2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949E71-938A-5567-A97C-CDCF259B62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D06CE9-3FB0-9BBE-B356-73DD7C1B87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483045-4140-ABD1-0E0D-426C2F7659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E6EB-0F18-478D-80CA-98A04370EC3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84CEEB-9028-5E92-82FC-54F32F86FB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D1BCD7-F55D-AD9D-6FC4-B77D8308F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36C34-6B31-437C-8257-023F2ED9DC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90925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9E40D18-3124-8198-B11A-7227500FDA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07DC27-0359-CE1E-9D89-A5DC212D23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C64FA2-C339-D7B0-8FCE-DEC0FACC62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7E6EB-0F18-478D-80CA-98A04370EC30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C4F7E0-9102-DCBD-A38E-A357D948BA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C01C2D-940E-E729-BEBA-192B2CB543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336C34-6B31-437C-8257-023F2ED9DC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04770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3" Type="http://schemas.microsoft.com/office/2007/relationships/hdphoto" Target="../media/hdphoto1.wdp"/><Relationship Id="rId7" Type="http://schemas.openxmlformats.org/officeDocument/2006/relationships/image" Target="../media/image4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f"/><Relationship Id="rId11" Type="http://schemas.openxmlformats.org/officeDocument/2006/relationships/image" Target="../media/image7.tiff"/><Relationship Id="rId5" Type="http://schemas.microsoft.com/office/2007/relationships/hdphoto" Target="../media/hdphoto2.wdp"/><Relationship Id="rId10" Type="http://schemas.microsoft.com/office/2007/relationships/hdphoto" Target="../media/hdphoto3.wdp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55">
            <a:extLst>
              <a:ext uri="{FF2B5EF4-FFF2-40B4-BE49-F238E27FC236}">
                <a16:creationId xmlns:a16="http://schemas.microsoft.com/office/drawing/2014/main" id="{533C07E6-536A-6582-C89A-41DE9A3125C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artisticPhotocopy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960" t="45321" r="32346" b="27341"/>
          <a:stretch/>
        </p:blipFill>
        <p:spPr>
          <a:xfrm>
            <a:off x="1939247" y="1667850"/>
            <a:ext cx="1073336" cy="726510"/>
          </a:xfrm>
          <a:prstGeom prst="rect">
            <a:avLst/>
          </a:prstGeom>
          <a:ln w="9525"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9EE1A17-A80D-DEAA-7A0E-1E8A3F694610}"/>
              </a:ext>
            </a:extLst>
          </p:cNvPr>
          <p:cNvSpPr txBox="1"/>
          <p:nvPr/>
        </p:nvSpPr>
        <p:spPr>
          <a:xfrm>
            <a:off x="3629399" y="228882"/>
            <a:ext cx="4763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ull length blots for Supplementary figure 3 E 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D19A6E1-DD4F-7D29-A36B-D23544F092A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920" t="39039" r="36153" b="19569"/>
          <a:stretch/>
        </p:blipFill>
        <p:spPr>
          <a:xfrm>
            <a:off x="4992481" y="1636602"/>
            <a:ext cx="1087401" cy="76954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E7788F5-BE41-6240-ED30-A1870C9AF7B6}"/>
              </a:ext>
            </a:extLst>
          </p:cNvPr>
          <p:cNvSpPr txBox="1"/>
          <p:nvPr/>
        </p:nvSpPr>
        <p:spPr>
          <a:xfrm>
            <a:off x="6450929" y="1262325"/>
            <a:ext cx="8647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>
                <a:latin typeface="Arial"/>
                <a:cs typeface="Arial"/>
              </a:rPr>
              <a:t>CamkIIa</a:t>
            </a:r>
            <a:r>
              <a:rPr lang="en-US" sz="800" dirty="0">
                <a:latin typeface="Arial"/>
                <a:cs typeface="Arial"/>
              </a:rPr>
              <a:t>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50kD</a:t>
            </a:r>
          </a:p>
          <a:p>
            <a:endParaRPr lang="en-US" sz="1000" dirty="0">
              <a:latin typeface="Arial"/>
              <a:cs typeface="Arial"/>
            </a:endParaRPr>
          </a:p>
        </p:txBody>
      </p:sp>
      <p:grpSp>
        <p:nvGrpSpPr>
          <p:cNvPr id="51" name="Group 50">
            <a:extLst>
              <a:ext uri="{FF2B5EF4-FFF2-40B4-BE49-F238E27FC236}">
                <a16:creationId xmlns:a16="http://schemas.microsoft.com/office/drawing/2014/main" id="{21CD073B-8991-B579-C068-E5FFFAD4A5DB}"/>
              </a:ext>
            </a:extLst>
          </p:cNvPr>
          <p:cNvGrpSpPr/>
          <p:nvPr/>
        </p:nvGrpSpPr>
        <p:grpSpPr>
          <a:xfrm>
            <a:off x="3277497" y="568759"/>
            <a:ext cx="1235230" cy="1254339"/>
            <a:chOff x="2055646" y="568758"/>
            <a:chExt cx="1235230" cy="1254339"/>
          </a:xfrm>
        </p:grpSpPr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26E62D27-128C-E9F6-CA9F-74028D115CAB}"/>
                </a:ext>
              </a:extLst>
            </p:cNvPr>
            <p:cNvGrpSpPr/>
            <p:nvPr/>
          </p:nvGrpSpPr>
          <p:grpSpPr>
            <a:xfrm>
              <a:off x="2055646" y="568758"/>
              <a:ext cx="1108737" cy="1254339"/>
              <a:chOff x="2055646" y="568758"/>
              <a:chExt cx="1108737" cy="1254339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0132B83B-DF89-A629-F8EB-27787EE2F0CD}"/>
                  </a:ext>
                </a:extLst>
              </p:cNvPr>
              <p:cNvSpPr txBox="1"/>
              <p:nvPr/>
            </p:nvSpPr>
            <p:spPr>
              <a:xfrm>
                <a:off x="2196101" y="1269099"/>
                <a:ext cx="864794" cy="553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/>
                    <a:cs typeface="Arial"/>
                  </a:rPr>
                  <a:t>CDK5</a:t>
                </a:r>
                <a:r>
                  <a:rPr lang="en-US" sz="800" dirty="0">
                    <a:latin typeface="Arial"/>
                    <a:cs typeface="Arial"/>
                  </a:rPr>
                  <a:t> </a:t>
                </a:r>
              </a:p>
              <a:p>
                <a:pPr algn="ctr"/>
                <a:r>
                  <a:rPr lang="en-US" sz="1000" dirty="0">
                    <a:latin typeface="Arial"/>
                    <a:cs typeface="Arial"/>
                  </a:rPr>
                  <a:t>~33kD</a:t>
                </a:r>
              </a:p>
              <a:p>
                <a:endParaRPr lang="en-US" sz="1000" dirty="0">
                  <a:latin typeface="Arial"/>
                  <a:cs typeface="Arial"/>
                </a:endParaRPr>
              </a:p>
            </p:txBody>
          </p:sp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2FE4440E-E5D0-7C8E-1B76-2251E458FF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duotone>
                  <a:prstClr val="black"/>
                  <a:schemeClr val="accent3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723" t="40260" r="32252" b="20012"/>
              <a:stretch/>
            </p:blipFill>
            <p:spPr>
              <a:xfrm>
                <a:off x="2055646" y="568758"/>
                <a:ext cx="1108737" cy="751046"/>
              </a:xfrm>
              <a:prstGeom prst="rect">
                <a:avLst/>
              </a:prstGeom>
            </p:spPr>
          </p:pic>
        </p:grp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DC51FFCE-B19F-B645-2982-E8ABB9554CF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64383" y="1028852"/>
              <a:ext cx="126493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DBCC8E63-C1B6-3EAF-3287-B4C4CC42A0BA}"/>
              </a:ext>
            </a:extLst>
          </p:cNvPr>
          <p:cNvCxnSpPr>
            <a:cxnSpLocks/>
          </p:cNvCxnSpPr>
          <p:nvPr/>
        </p:nvCxnSpPr>
        <p:spPr>
          <a:xfrm flipH="1">
            <a:off x="7379283" y="881052"/>
            <a:ext cx="126493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9" name="Picture 18">
            <a:extLst>
              <a:ext uri="{FF2B5EF4-FFF2-40B4-BE49-F238E27FC236}">
                <a16:creationId xmlns:a16="http://schemas.microsoft.com/office/drawing/2014/main" id="{3459C08C-D18A-4467-E7A3-C366BF521BE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73" t="8012" r="19468" b="18398"/>
          <a:stretch/>
        </p:blipFill>
        <p:spPr>
          <a:xfrm>
            <a:off x="4897062" y="568613"/>
            <a:ext cx="1017022" cy="693712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E1BB45CE-363C-6CF9-3666-DADB00ED7696}"/>
              </a:ext>
            </a:extLst>
          </p:cNvPr>
          <p:cNvSpPr txBox="1"/>
          <p:nvPr/>
        </p:nvSpPr>
        <p:spPr>
          <a:xfrm>
            <a:off x="4968405" y="1196431"/>
            <a:ext cx="8647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/>
                <a:cs typeface="Arial"/>
              </a:rPr>
              <a:t>ERK2</a:t>
            </a:r>
            <a:r>
              <a:rPr lang="en-US" sz="800" dirty="0">
                <a:latin typeface="Arial"/>
                <a:cs typeface="Arial"/>
              </a:rPr>
              <a:t>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42kD</a:t>
            </a:r>
          </a:p>
          <a:p>
            <a:endParaRPr lang="en-US" sz="1000" dirty="0">
              <a:latin typeface="Arial"/>
              <a:cs typeface="Arial"/>
            </a:endParaRP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DBE65E82-77C0-5A3A-E84A-630968ECD1B7}"/>
              </a:ext>
            </a:extLst>
          </p:cNvPr>
          <p:cNvCxnSpPr>
            <a:cxnSpLocks/>
          </p:cNvCxnSpPr>
          <p:nvPr/>
        </p:nvCxnSpPr>
        <p:spPr>
          <a:xfrm flipH="1">
            <a:off x="2922175" y="1845673"/>
            <a:ext cx="126493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D73C3AA4-25B9-5B6F-6A5A-F64C5B60B03B}"/>
              </a:ext>
            </a:extLst>
          </p:cNvPr>
          <p:cNvSpPr txBox="1"/>
          <p:nvPr/>
        </p:nvSpPr>
        <p:spPr>
          <a:xfrm>
            <a:off x="1975697" y="2340517"/>
            <a:ext cx="8647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/>
                <a:cs typeface="Arial"/>
              </a:rPr>
              <a:t>MARK1</a:t>
            </a:r>
            <a:r>
              <a:rPr lang="en-US" sz="800" dirty="0">
                <a:latin typeface="Arial"/>
                <a:cs typeface="Arial"/>
              </a:rPr>
              <a:t>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85kD</a:t>
            </a:r>
          </a:p>
          <a:p>
            <a:endParaRPr lang="en-US" sz="1000" dirty="0">
              <a:latin typeface="Arial"/>
              <a:cs typeface="Arial"/>
            </a:endParaRP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6215B589-44E1-09C2-BAC9-533E0A251538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94" t="44365" r="34256" b="12519"/>
          <a:stretch/>
        </p:blipFill>
        <p:spPr>
          <a:xfrm>
            <a:off x="3387156" y="1637522"/>
            <a:ext cx="1141844" cy="756838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AD3C8EFF-C0D9-2A29-DB19-DE718C311C7A}"/>
              </a:ext>
            </a:extLst>
          </p:cNvPr>
          <p:cNvSpPr txBox="1"/>
          <p:nvPr/>
        </p:nvSpPr>
        <p:spPr>
          <a:xfrm>
            <a:off x="3525681" y="2381096"/>
            <a:ext cx="8647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/>
                <a:cs typeface="Arial"/>
              </a:rPr>
              <a:t>RACK1</a:t>
            </a:r>
            <a:r>
              <a:rPr lang="en-US" sz="800" dirty="0">
                <a:latin typeface="Arial"/>
                <a:cs typeface="Arial"/>
              </a:rPr>
              <a:t>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31kD</a:t>
            </a:r>
          </a:p>
          <a:p>
            <a:endParaRPr lang="en-US" sz="1000" dirty="0">
              <a:latin typeface="Arial"/>
              <a:cs typeface="Arial"/>
            </a:endParaRP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D4603FFA-9429-AAA4-60A7-B095DC32F85B}"/>
              </a:ext>
            </a:extLst>
          </p:cNvPr>
          <p:cNvCxnSpPr>
            <a:cxnSpLocks/>
          </p:cNvCxnSpPr>
          <p:nvPr/>
        </p:nvCxnSpPr>
        <p:spPr>
          <a:xfrm flipH="1">
            <a:off x="4507632" y="2175741"/>
            <a:ext cx="126493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BBD86EE6-8766-78C3-BB2C-9102FC263067}"/>
              </a:ext>
            </a:extLst>
          </p:cNvPr>
          <p:cNvSpPr txBox="1"/>
          <p:nvPr/>
        </p:nvSpPr>
        <p:spPr>
          <a:xfrm>
            <a:off x="4658423" y="2351659"/>
            <a:ext cx="1755774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/>
                <a:cs typeface="Arial"/>
              </a:rPr>
              <a:t>Tubulin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55kD</a:t>
            </a:r>
          </a:p>
          <a:p>
            <a:pPr algn="ctr"/>
            <a:r>
              <a:rPr lang="en-US" sz="800" dirty="0">
                <a:latin typeface="Arial"/>
                <a:cs typeface="Arial"/>
              </a:rPr>
              <a:t>(CDK5 blot re-probed with tubulin)</a:t>
            </a:r>
          </a:p>
          <a:p>
            <a:endParaRPr lang="en-US" sz="1000" dirty="0">
              <a:latin typeface="Arial"/>
              <a:cs typeface="Arial"/>
            </a:endParaRP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DFA10EE6-8A88-DB2A-1DCD-017802E513AA}"/>
              </a:ext>
            </a:extLst>
          </p:cNvPr>
          <p:cNvCxnSpPr>
            <a:cxnSpLocks/>
          </p:cNvCxnSpPr>
          <p:nvPr/>
        </p:nvCxnSpPr>
        <p:spPr>
          <a:xfrm flipH="1">
            <a:off x="6092841" y="1925085"/>
            <a:ext cx="126493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48" name="Group 47">
            <a:extLst>
              <a:ext uri="{FF2B5EF4-FFF2-40B4-BE49-F238E27FC236}">
                <a16:creationId xmlns:a16="http://schemas.microsoft.com/office/drawing/2014/main" id="{AB1B309E-5AAC-6E7C-8D20-56F250D5099E}"/>
              </a:ext>
            </a:extLst>
          </p:cNvPr>
          <p:cNvGrpSpPr/>
          <p:nvPr/>
        </p:nvGrpSpPr>
        <p:grpSpPr>
          <a:xfrm>
            <a:off x="1540691" y="684256"/>
            <a:ext cx="1459836" cy="1124235"/>
            <a:chOff x="430160" y="684255"/>
            <a:chExt cx="1459836" cy="1124235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0CDB1FC-B1E3-035C-B6F1-B03477B226BF}"/>
                </a:ext>
              </a:extLst>
            </p:cNvPr>
            <p:cNvSpPr txBox="1"/>
            <p:nvPr/>
          </p:nvSpPr>
          <p:spPr>
            <a:xfrm>
              <a:off x="884542" y="1254492"/>
              <a:ext cx="864794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/>
                  <a:cs typeface="Arial"/>
                </a:rPr>
                <a:t>GSK3</a:t>
              </a:r>
              <a:r>
                <a:rPr lang="el-GR" sz="1000" dirty="0">
                  <a:latin typeface="Arial"/>
                  <a:cs typeface="Arial"/>
                </a:rPr>
                <a:t>β</a:t>
              </a:r>
              <a:r>
                <a:rPr lang="en-US" sz="800" dirty="0">
                  <a:latin typeface="Arial"/>
                  <a:cs typeface="Arial"/>
                </a:rPr>
                <a:t> </a:t>
              </a:r>
            </a:p>
            <a:p>
              <a:pPr algn="ctr"/>
              <a:r>
                <a:rPr lang="en-US" sz="1000" dirty="0">
                  <a:latin typeface="Arial"/>
                  <a:cs typeface="Arial"/>
                </a:rPr>
                <a:t>~48kD</a:t>
              </a:r>
            </a:p>
            <a:p>
              <a:endParaRPr lang="en-US" sz="1000" dirty="0">
                <a:latin typeface="Arial"/>
                <a:cs typeface="Arial"/>
              </a:endParaRPr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5742DCC3-D96A-9C09-4475-FD0170EF64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63503" y="844275"/>
              <a:ext cx="126493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7C82A50-59BA-25B2-0201-490238F4DA7B}"/>
                </a:ext>
              </a:extLst>
            </p:cNvPr>
            <p:cNvSpPr txBox="1"/>
            <p:nvPr/>
          </p:nvSpPr>
          <p:spPr>
            <a:xfrm>
              <a:off x="446313" y="684255"/>
              <a:ext cx="396264" cy="1789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63" dirty="0">
                  <a:latin typeface="Arial"/>
                  <a:cs typeface="Arial"/>
                </a:rPr>
                <a:t>~50kD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F11CFB2-3242-0B48-39B5-54D23FC0AA3F}"/>
                </a:ext>
              </a:extLst>
            </p:cNvPr>
            <p:cNvSpPr txBox="1"/>
            <p:nvPr/>
          </p:nvSpPr>
          <p:spPr>
            <a:xfrm>
              <a:off x="430160" y="831448"/>
              <a:ext cx="396262" cy="1789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63" dirty="0">
                  <a:latin typeface="Arial"/>
                  <a:cs typeface="Arial"/>
                </a:rPr>
                <a:t>~37kD</a:t>
              </a:r>
            </a:p>
          </p:txBody>
        </p:sp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F5F0409F-7A6E-F151-DE99-FB12788D2A4C}"/>
                </a:ext>
              </a:extLst>
            </p:cNvPr>
            <p:cNvCxnSpPr>
              <a:cxnSpLocks/>
            </p:cNvCxnSpPr>
            <p:nvPr/>
          </p:nvCxnSpPr>
          <p:spPr>
            <a:xfrm>
              <a:off x="747147" y="913363"/>
              <a:ext cx="137620" cy="0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A228B44B-7321-09D3-0C65-157073F759A5}"/>
              </a:ext>
            </a:extLst>
          </p:cNvPr>
          <p:cNvSpPr txBox="1"/>
          <p:nvPr/>
        </p:nvSpPr>
        <p:spPr>
          <a:xfrm>
            <a:off x="2875892" y="993197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25kD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EFBA23E-C442-1A7C-DBF9-CA50AAB63732}"/>
              </a:ext>
            </a:extLst>
          </p:cNvPr>
          <p:cNvSpPr txBox="1"/>
          <p:nvPr/>
        </p:nvSpPr>
        <p:spPr>
          <a:xfrm>
            <a:off x="2882443" y="888842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37kD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14860A62-6634-F770-1817-D867661FCD67}"/>
              </a:ext>
            </a:extLst>
          </p:cNvPr>
          <p:cNvCxnSpPr>
            <a:cxnSpLocks/>
          </p:cNvCxnSpPr>
          <p:nvPr/>
        </p:nvCxnSpPr>
        <p:spPr>
          <a:xfrm>
            <a:off x="3181233" y="978283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18E95A7D-516A-2791-0E0C-D4A5056CFD5E}"/>
              </a:ext>
            </a:extLst>
          </p:cNvPr>
          <p:cNvCxnSpPr>
            <a:cxnSpLocks/>
          </p:cNvCxnSpPr>
          <p:nvPr/>
        </p:nvCxnSpPr>
        <p:spPr>
          <a:xfrm>
            <a:off x="3183508" y="1066994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8F97B039-CC01-D2EC-0E29-A32F7FCF168A}"/>
              </a:ext>
            </a:extLst>
          </p:cNvPr>
          <p:cNvSpPr txBox="1"/>
          <p:nvPr/>
        </p:nvSpPr>
        <p:spPr>
          <a:xfrm>
            <a:off x="1563009" y="1829764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75kD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4F3E202-8920-6FA4-7E38-247CE097AAD6}"/>
              </a:ext>
            </a:extLst>
          </p:cNvPr>
          <p:cNvSpPr txBox="1"/>
          <p:nvPr/>
        </p:nvSpPr>
        <p:spPr>
          <a:xfrm>
            <a:off x="1519062" y="1740942"/>
            <a:ext cx="436338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100kD</a:t>
            </a: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2AAB2F04-64E8-8431-ED1D-2913C03C5936}"/>
              </a:ext>
            </a:extLst>
          </p:cNvPr>
          <p:cNvCxnSpPr>
            <a:cxnSpLocks/>
          </p:cNvCxnSpPr>
          <p:nvPr/>
        </p:nvCxnSpPr>
        <p:spPr>
          <a:xfrm>
            <a:off x="1891218" y="1906809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4F4A960F-B6DD-1A60-415E-46ED9581DEC6}"/>
              </a:ext>
            </a:extLst>
          </p:cNvPr>
          <p:cNvCxnSpPr>
            <a:cxnSpLocks/>
          </p:cNvCxnSpPr>
          <p:nvPr/>
        </p:nvCxnSpPr>
        <p:spPr>
          <a:xfrm>
            <a:off x="1864102" y="1823598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F6B1525D-6C6B-7BDD-87C4-30B71E05B0E8}"/>
              </a:ext>
            </a:extLst>
          </p:cNvPr>
          <p:cNvCxnSpPr>
            <a:cxnSpLocks/>
          </p:cNvCxnSpPr>
          <p:nvPr/>
        </p:nvCxnSpPr>
        <p:spPr>
          <a:xfrm>
            <a:off x="4755481" y="899570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342CA80B-08B1-58CC-24EA-DBA2F14A11C1}"/>
              </a:ext>
            </a:extLst>
          </p:cNvPr>
          <p:cNvCxnSpPr>
            <a:cxnSpLocks/>
          </p:cNvCxnSpPr>
          <p:nvPr/>
        </p:nvCxnSpPr>
        <p:spPr>
          <a:xfrm>
            <a:off x="4757756" y="1048571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20B583B3-805D-3A85-9638-046F9B950A22}"/>
              </a:ext>
            </a:extLst>
          </p:cNvPr>
          <p:cNvCxnSpPr>
            <a:cxnSpLocks/>
          </p:cNvCxnSpPr>
          <p:nvPr/>
        </p:nvCxnSpPr>
        <p:spPr>
          <a:xfrm flipH="1">
            <a:off x="5895167" y="985307"/>
            <a:ext cx="126493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9A92CC21-6E08-87AA-5CA1-584B512D680C}"/>
              </a:ext>
            </a:extLst>
          </p:cNvPr>
          <p:cNvSpPr txBox="1"/>
          <p:nvPr/>
        </p:nvSpPr>
        <p:spPr>
          <a:xfrm>
            <a:off x="4451252" y="805980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50kD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CDCEBC2-3E71-3ACC-AA64-0E943C726E89}"/>
              </a:ext>
            </a:extLst>
          </p:cNvPr>
          <p:cNvSpPr txBox="1"/>
          <p:nvPr/>
        </p:nvSpPr>
        <p:spPr>
          <a:xfrm>
            <a:off x="4452930" y="958380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37kD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EA67BCE6-A11A-AD2C-FA86-89E86E7DEEC4}"/>
              </a:ext>
            </a:extLst>
          </p:cNvPr>
          <p:cNvGrpSpPr/>
          <p:nvPr/>
        </p:nvGrpSpPr>
        <p:grpSpPr>
          <a:xfrm>
            <a:off x="5942382" y="731283"/>
            <a:ext cx="462771" cy="343311"/>
            <a:chOff x="4418381" y="731282"/>
            <a:chExt cx="462771" cy="343311"/>
          </a:xfrm>
        </p:grpSpPr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1D9F548C-903E-DD39-EA81-F1B050715090}"/>
                </a:ext>
              </a:extLst>
            </p:cNvPr>
            <p:cNvSpPr txBox="1"/>
            <p:nvPr/>
          </p:nvSpPr>
          <p:spPr>
            <a:xfrm>
              <a:off x="4418381" y="731282"/>
              <a:ext cx="396262" cy="1789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63" dirty="0">
                  <a:latin typeface="Arial"/>
                  <a:cs typeface="Arial"/>
                </a:rPr>
                <a:t>~50kD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37CD96C2-3821-1550-6F5D-8AE7C37BE9B7}"/>
                </a:ext>
              </a:extLst>
            </p:cNvPr>
            <p:cNvSpPr txBox="1"/>
            <p:nvPr/>
          </p:nvSpPr>
          <p:spPr>
            <a:xfrm>
              <a:off x="4437988" y="895633"/>
              <a:ext cx="396262" cy="1789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63" dirty="0">
                  <a:latin typeface="Arial"/>
                  <a:cs typeface="Arial"/>
                </a:rPr>
                <a:t>~37kD</a:t>
              </a:r>
            </a:p>
          </p:txBody>
        </p:sp>
        <p:cxnSp>
          <p:nvCxnSpPr>
            <p:cNvPr id="69" name="Straight Arrow Connector 68">
              <a:extLst>
                <a:ext uri="{FF2B5EF4-FFF2-40B4-BE49-F238E27FC236}">
                  <a16:creationId xmlns:a16="http://schemas.microsoft.com/office/drawing/2014/main" id="{F1A71444-69CB-3A11-5577-1B216AA5AB2B}"/>
                </a:ext>
              </a:extLst>
            </p:cNvPr>
            <p:cNvCxnSpPr>
              <a:cxnSpLocks/>
            </p:cNvCxnSpPr>
            <p:nvPr/>
          </p:nvCxnSpPr>
          <p:spPr>
            <a:xfrm>
              <a:off x="4740538" y="986232"/>
              <a:ext cx="137620" cy="0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Straight Arrow Connector 69">
              <a:extLst>
                <a:ext uri="{FF2B5EF4-FFF2-40B4-BE49-F238E27FC236}">
                  <a16:creationId xmlns:a16="http://schemas.microsoft.com/office/drawing/2014/main" id="{F02EFD92-237B-7596-FF3A-F6B71A4C1CA2}"/>
                </a:ext>
              </a:extLst>
            </p:cNvPr>
            <p:cNvCxnSpPr>
              <a:cxnSpLocks/>
            </p:cNvCxnSpPr>
            <p:nvPr/>
          </p:nvCxnSpPr>
          <p:spPr>
            <a:xfrm>
              <a:off x="4743532" y="815903"/>
              <a:ext cx="137620" cy="0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71" name="Picture 70">
            <a:extLst>
              <a:ext uri="{FF2B5EF4-FFF2-40B4-BE49-F238E27FC236}">
                <a16:creationId xmlns:a16="http://schemas.microsoft.com/office/drawing/2014/main" id="{4F15FF12-6AD5-D58C-1F4B-9B827ECFB5D3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526" t="47387" r="37102" b="22145"/>
          <a:stretch/>
        </p:blipFill>
        <p:spPr>
          <a:xfrm>
            <a:off x="6402467" y="538006"/>
            <a:ext cx="977726" cy="786179"/>
          </a:xfrm>
          <a:prstGeom prst="rect">
            <a:avLst/>
          </a:prstGeom>
          <a:ln>
            <a:noFill/>
          </a:ln>
        </p:spPr>
      </p:pic>
      <p:sp>
        <p:nvSpPr>
          <p:cNvPr id="73" name="TextBox 72">
            <a:extLst>
              <a:ext uri="{FF2B5EF4-FFF2-40B4-BE49-F238E27FC236}">
                <a16:creationId xmlns:a16="http://schemas.microsoft.com/office/drawing/2014/main" id="{525DAE86-483C-226A-0CF3-452E82844B69}"/>
              </a:ext>
            </a:extLst>
          </p:cNvPr>
          <p:cNvSpPr txBox="1"/>
          <p:nvPr/>
        </p:nvSpPr>
        <p:spPr>
          <a:xfrm>
            <a:off x="3015438" y="2033464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37kD</a:t>
            </a:r>
          </a:p>
        </p:txBody>
      </p: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04928BDE-91CF-AAF4-0EB3-0AEF7BD79D90}"/>
              </a:ext>
            </a:extLst>
          </p:cNvPr>
          <p:cNvCxnSpPr>
            <a:cxnSpLocks/>
          </p:cNvCxnSpPr>
          <p:nvPr/>
        </p:nvCxnSpPr>
        <p:spPr>
          <a:xfrm>
            <a:off x="3321123" y="2124754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90453702-B683-E3DA-3FE4-D5A01A64821E}"/>
              </a:ext>
            </a:extLst>
          </p:cNvPr>
          <p:cNvSpPr txBox="1"/>
          <p:nvPr/>
        </p:nvSpPr>
        <p:spPr>
          <a:xfrm>
            <a:off x="4583688" y="1845790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50kD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02C56193-A41D-118A-0DBB-B5A5E6B0941D}"/>
              </a:ext>
            </a:extLst>
          </p:cNvPr>
          <p:cNvCxnSpPr>
            <a:cxnSpLocks/>
          </p:cNvCxnSpPr>
          <p:nvPr/>
        </p:nvCxnSpPr>
        <p:spPr>
          <a:xfrm>
            <a:off x="4877026" y="1930412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43" name="Picture 42">
            <a:extLst>
              <a:ext uri="{FF2B5EF4-FFF2-40B4-BE49-F238E27FC236}">
                <a16:creationId xmlns:a16="http://schemas.microsoft.com/office/drawing/2014/main" id="{4B11A64E-6159-1D0E-4403-B86099DC9B67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53" t="43752" r="26386" b="22240"/>
          <a:stretch/>
        </p:blipFill>
        <p:spPr>
          <a:xfrm>
            <a:off x="1986701" y="506871"/>
            <a:ext cx="919324" cy="804032"/>
          </a:xfrm>
          <a:prstGeom prst="rect">
            <a:avLst/>
          </a:prstGeom>
          <a:ln w="9525">
            <a:noFill/>
          </a:ln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76A055C9-3455-C96D-AD22-1BB8A8A9FE3C}"/>
              </a:ext>
            </a:extLst>
          </p:cNvPr>
          <p:cNvCxnSpPr>
            <a:cxnSpLocks/>
          </p:cNvCxnSpPr>
          <p:nvPr/>
        </p:nvCxnSpPr>
        <p:spPr>
          <a:xfrm>
            <a:off x="1883078" y="780013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16EA4429-4C3B-EEDD-AC09-7C20187C7893}"/>
              </a:ext>
            </a:extLst>
          </p:cNvPr>
          <p:cNvSpPr txBox="1"/>
          <p:nvPr/>
        </p:nvSpPr>
        <p:spPr>
          <a:xfrm>
            <a:off x="3022141" y="2155720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25kD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263183BD-9587-607F-8C88-D6A9B8645265}"/>
              </a:ext>
            </a:extLst>
          </p:cNvPr>
          <p:cNvCxnSpPr>
            <a:cxnSpLocks/>
          </p:cNvCxnSpPr>
          <p:nvPr/>
        </p:nvCxnSpPr>
        <p:spPr>
          <a:xfrm>
            <a:off x="3332847" y="2241986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D8B1ADA3-DFA1-3649-CC1C-F3E115D7AFA1}"/>
              </a:ext>
            </a:extLst>
          </p:cNvPr>
          <p:cNvSpPr txBox="1"/>
          <p:nvPr/>
        </p:nvSpPr>
        <p:spPr>
          <a:xfrm>
            <a:off x="4576417" y="1953626"/>
            <a:ext cx="396262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dirty="0">
                <a:latin typeface="Arial"/>
                <a:cs typeface="Arial"/>
              </a:rPr>
              <a:t>~37kD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BBEC782D-7F5A-E4B6-41E1-9C5D0261E2EA}"/>
              </a:ext>
            </a:extLst>
          </p:cNvPr>
          <p:cNvCxnSpPr>
            <a:cxnSpLocks/>
          </p:cNvCxnSpPr>
          <p:nvPr/>
        </p:nvCxnSpPr>
        <p:spPr>
          <a:xfrm>
            <a:off x="4883725" y="2042620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662036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5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atakshi Shukla</dc:creator>
  <cp:lastModifiedBy>Shatakshi Shukla</cp:lastModifiedBy>
  <cp:revision>1</cp:revision>
  <dcterms:created xsi:type="dcterms:W3CDTF">2025-10-12T03:57:58Z</dcterms:created>
  <dcterms:modified xsi:type="dcterms:W3CDTF">2025-10-12T03:58:13Z</dcterms:modified>
</cp:coreProperties>
</file>